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906000" type="A4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66" d="100"/>
          <a:sy n="66" d="100"/>
        </p:scale>
        <p:origin x="3276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76363" cy="513508"/>
          </a:xfrm>
          <a:prstGeom prst="rect">
            <a:avLst/>
          </a:prstGeom>
        </p:spPr>
        <p:txBody>
          <a:bodyPr vert="horz" lIns="99026" tIns="49513" rIns="99026" bIns="49513" rtlCol="0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9026" tIns="49513" rIns="99026" bIns="49513" rtlCol="0"/>
          <a:lstStyle>
            <a:lvl1pPr algn="r">
              <a:defRPr sz="1300"/>
            </a:lvl1pPr>
          </a:lstStyle>
          <a:p>
            <a:fld id="{370EAC04-371B-419C-BEAC-4CF302C7C588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26" tIns="49513" rIns="99026" bIns="49513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9930" y="4925408"/>
            <a:ext cx="5679440" cy="4029879"/>
          </a:xfrm>
          <a:prstGeom prst="rect">
            <a:avLst/>
          </a:prstGeom>
        </p:spPr>
        <p:txBody>
          <a:bodyPr vert="horz" lIns="99026" tIns="49513" rIns="99026" bIns="49513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1" y="9721107"/>
            <a:ext cx="3076363" cy="513507"/>
          </a:xfrm>
          <a:prstGeom prst="rect">
            <a:avLst/>
          </a:prstGeom>
        </p:spPr>
        <p:txBody>
          <a:bodyPr vert="horz" lIns="99026" tIns="49513" rIns="99026" bIns="49513" rtlCol="0" anchor="b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9026" tIns="49513" rIns="99026" bIns="49513" rtlCol="0" anchor="b"/>
          <a:lstStyle>
            <a:lvl1pPr algn="r">
              <a:defRPr sz="1300"/>
            </a:lvl1pPr>
          </a:lstStyle>
          <a:p>
            <a:fld id="{5F626A4B-AF7A-4AF1-A8C5-A9D3F37D4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1332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F626A4B-AF7A-4AF1-A8C5-A9D3F37D413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36987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5418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9479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745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207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224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3342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5494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486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821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52605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2283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9D6C29-3AB0-4558-B10F-90A56D869C4A}" type="datetimeFigureOut">
              <a:rPr lang="zh-CN" altLang="en-US" smtClean="0"/>
              <a:t>2016/6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757AC9-39BC-432D-B914-D3CCF81623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9599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68"/>
          <a:stretch/>
        </p:blipFill>
        <p:spPr>
          <a:xfrm>
            <a:off x="1" y="1080669"/>
            <a:ext cx="6833744" cy="3001383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22"/>
          <a:stretch/>
        </p:blipFill>
        <p:spPr>
          <a:xfrm>
            <a:off x="0" y="4645532"/>
            <a:ext cx="6833744" cy="2996356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315728" y="7937500"/>
            <a:ext cx="6396683" cy="11399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.  GO (Gene Ontology) Enrichment of differentially expressed genes.</a:t>
            </a:r>
          </a:p>
          <a:p>
            <a:pPr algn="just">
              <a:lnSpc>
                <a:spcPct val="200000"/>
              </a:lnSpc>
            </a:pPr>
            <a:r>
              <a:rPr lang="en-US" altLang="zh-CN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 GO Enrichment of differentially expressed genes between parents, (b) GO Enrichment of differentially expressed genes between bulked RILs</a:t>
            </a:r>
            <a:endParaRPr lang="zh-CN" altLang="en-US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315728" y="859895"/>
            <a:ext cx="317716" cy="397031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/>
              <a:t>A</a:t>
            </a:r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 smtClean="0"/>
          </a:p>
          <a:p>
            <a:endParaRPr lang="en-US" altLang="zh-CN" dirty="0"/>
          </a:p>
          <a:p>
            <a:r>
              <a:rPr lang="en-US" altLang="zh-CN" dirty="0" smtClean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211328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6</Words>
  <Application>Microsoft Office PowerPoint</Application>
  <PresentationFormat>A4 纸张(210x297 毫米)</PresentationFormat>
  <Paragraphs>1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mycompu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立凯</dc:creator>
  <cp:lastModifiedBy>陈立凯</cp:lastModifiedBy>
  <cp:revision>3</cp:revision>
  <cp:lastPrinted>2016-06-04T08:38:45Z</cp:lastPrinted>
  <dcterms:created xsi:type="dcterms:W3CDTF">2016-06-04T08:21:53Z</dcterms:created>
  <dcterms:modified xsi:type="dcterms:W3CDTF">2016-06-04T08:40:12Z</dcterms:modified>
</cp:coreProperties>
</file>